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7561263" cy="10693400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ude" initials="A" lastIdx="2" clrIdx="0"/>
  <p:cmAuthor id="1" name="SusanE Ford" initials="SF" lastIdx="8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708" y="2952"/>
      </p:cViewPr>
      <p:guideLst>
        <p:guide orient="horz" pos="3368"/>
        <p:guide pos="23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8E823F-BA4A-4C75-95CB-808A8FA2BAA7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82800" y="744538"/>
            <a:ext cx="26320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E3E0EB-2843-4735-BA5D-517C0F1E443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54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67095" y="3321886"/>
            <a:ext cx="6427074" cy="229215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660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9222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481916" y="428232"/>
            <a:ext cx="1701284" cy="912404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78063" y="428232"/>
            <a:ext cx="4977831" cy="912404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62965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2905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97287" y="6871500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97287" y="4532320"/>
            <a:ext cx="6427074" cy="233918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135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78063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843642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1391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3" y="2393639"/>
            <a:ext cx="3340871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8063" y="3391194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841017" y="2393639"/>
            <a:ext cx="3342183" cy="99755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841017" y="3391194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59602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5033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85920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78064" y="425756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56244" y="425756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78064" y="2237694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9698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0291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78063" y="428232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78063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78063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AA7593-45E0-4DF4-9CE3-3C21281592EA}" type="datetimeFigureOut">
              <a:rPr lang="fr-FR" smtClean="0"/>
              <a:t>28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583432" y="9911198"/>
            <a:ext cx="2394400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5418905" y="9911198"/>
            <a:ext cx="1764295" cy="5693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C01D0-9FE6-47FF-9168-E573D4DE1E4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85067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08223" y="8227020"/>
            <a:ext cx="7200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fr-FR" sz="1200" dirty="0" smtClean="0"/>
          </a:p>
        </p:txBody>
      </p:sp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03132736"/>
              </p:ext>
            </p:extLst>
          </p:nvPr>
        </p:nvGraphicFramePr>
        <p:xfrm>
          <a:off x="108223" y="234135"/>
          <a:ext cx="7344815" cy="784466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015847"/>
                <a:gridCol w="894653"/>
                <a:gridCol w="1089457"/>
                <a:gridCol w="1385270"/>
                <a:gridCol w="382393"/>
                <a:gridCol w="577195"/>
              </a:tblGrid>
              <a:tr h="119388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 err="1">
                          <a:effectLst/>
                        </a:rPr>
                        <a:t>Unfected</a:t>
                      </a:r>
                      <a:r>
                        <a:rPr lang="fr-FR" sz="800" u="none" strike="noStrike" dirty="0">
                          <a:effectLst/>
                        </a:rPr>
                        <a:t> &gt; </a:t>
                      </a:r>
                      <a:r>
                        <a:rPr lang="fr-FR" sz="800" u="none" strike="noStrike" dirty="0" err="1">
                          <a:effectLst/>
                        </a:rPr>
                        <a:t>Infected</a:t>
                      </a:r>
                      <a:endParaRPr lang="fr-FR" sz="800" b="1" i="0" u="none" strike="noStrike" dirty="0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19388"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nnotation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ccession number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GO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Name and other names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R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Discussed</a:t>
                      </a:r>
                      <a:endParaRPr lang="fr-FR" sz="800" b="1" i="0" u="none" strike="noStrike">
                        <a:solidFill>
                          <a:srgbClr val="FFFFFF"/>
                        </a:solidFill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DC45-related prote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653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apoptosis/cell cycl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dc45l, Cdc4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ntrosomal protein of 63 kDa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454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ep6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4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evelopmentally-regulated GTP-binding protein 2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948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RG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rotein NEDD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116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NEDD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hromobox protein homolog 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382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bx1, cbx, HP1-bet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GrpE protein homolog 1, mitochondrial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057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Grpel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denosine 3'-phospho 5'-phosphosulfate transporter 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776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20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cell signalling/cell activatio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apst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4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Growth factor receptor-bound protein 2 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ES7891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Grb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3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Mitochondrial import inner membrane translocase subunit Tim16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078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im1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as-like protein 3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BQ42729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as-like protein 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 err="1">
                          <a:effectLst/>
                        </a:rPr>
                        <a:t>Selenoprotein</a:t>
                      </a:r>
                      <a:r>
                        <a:rPr lang="fr-FR" sz="800" u="none" strike="noStrike" dirty="0">
                          <a:effectLst/>
                        </a:rPr>
                        <a:t> T2</a:t>
                      </a:r>
                      <a:endParaRPr lang="fr-FR" sz="800" b="0" i="0" u="none" strike="noStrike" dirty="0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441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elt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erine/threonine-protein phosphatase 2A regulatory subunit A alpha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K17233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PP2R1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pectrin alpha chain, brain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006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ptan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-complex protein 1 subunit gamma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EE67771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CT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Amyloid beta A4 precursor protein-binding family A member 2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882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pba2, Mint2, X11L, Lin1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3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disintegrin and metalloproteinase with thrombospondin motifs 16 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DV73691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DAMTS1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almodulin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D52683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almodul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Dual specificity protein phosphatase 7 (Fragment)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505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usp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Integral membrane protein 2A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787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ITM2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eptidase M12B, ADAM/reprolysin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456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DAM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NADH dehydrogenase 1 beta subcomplex subunit 11, mitochondrial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562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NDUFB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uclear protein localization protein 4 homolog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907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Nploc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rotein FAM151B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186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FAM151B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3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CPG Rhodopsin receptor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684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CPG Rhodops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4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terol regulatory element-binding protein 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BQ42693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REBF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enascin-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623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NXB, Tenasc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eptin-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398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Cell structur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eptin-1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ropomyosin-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EW77946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Tropomyosin-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ctivin receptor type-2A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533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immunity/inflammatio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cvr2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5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emicentin-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245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MCN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3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 Fatty acid synthas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638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metabolism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FAS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4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3-keto-steroid reductase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663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SD17B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denylate kinase isoenzyme 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139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AK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5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Ornithine aminotransferase, mitochondrial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549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Oat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erine palmitoyltransferase 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750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PTLC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BTB/POZ domain-containing protein KCTD7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196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nervous system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Kctd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3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Brain protein I3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68282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Bri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3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Survival of motor neuron-related-splicing factor 30 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994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mndc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Lys-63-specific deubiquitinase BRCC3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X73938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proteasom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brcc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imilar to ubiquitin-protein ligase-lik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9493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ubiquitin-protein ligase-lik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4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Ubiquitin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BQ42705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Ubiquitin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22897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 err="1">
                          <a:effectLst/>
                        </a:rPr>
                        <a:t>Ubiquitin-conjugating</a:t>
                      </a:r>
                      <a:r>
                        <a:rPr lang="fr-FR" sz="800" u="none" strike="noStrike" dirty="0">
                          <a:effectLst/>
                        </a:rPr>
                        <a:t> enzyme E2</a:t>
                      </a:r>
                      <a:endParaRPr lang="fr-FR" sz="800" b="0" i="0" u="none" strike="noStrike" dirty="0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X06921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Ubiquitin-conjugating enzyme E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Butyrate response factor 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ES78958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Replication/transcription and DNA repair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Zfp36l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NA excision repair protein ERCC-8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532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ERCC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r1-associated corepressor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714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Drap1 , NC2-Alpha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4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pliceosome RNA helicase Bat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F07569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Bat1, BAR1, DDX39B, UAP5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istidyl-tRNA synthetase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EW77789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hisS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Krueppel-like factor 6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DW71385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Krueppel-like factor 6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6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Membrane protein FAM174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659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fam17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Nucleoporin p54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445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Nup5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Nucleosome assembly protein 1-like 4 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806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NAP1L4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rotein max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441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Ma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NA-binding protein 7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406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BM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 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 dirty="0">
                          <a:effectLst/>
                        </a:rPr>
                        <a:t>PR </a:t>
                      </a:r>
                      <a:r>
                        <a:rPr lang="fr-FR" sz="800" u="none" strike="noStrike" dirty="0" err="1">
                          <a:effectLst/>
                        </a:rPr>
                        <a:t>domain</a:t>
                      </a:r>
                      <a:r>
                        <a:rPr lang="fr-FR" sz="800" u="none" strike="noStrike" dirty="0">
                          <a:effectLst/>
                        </a:rPr>
                        <a:t> zinc </a:t>
                      </a:r>
                      <a:r>
                        <a:rPr lang="fr-FR" sz="800" u="none" strike="noStrike" dirty="0" err="1">
                          <a:effectLst/>
                        </a:rPr>
                        <a:t>finger</a:t>
                      </a:r>
                      <a:r>
                        <a:rPr lang="fr-FR" sz="800" u="none" strike="noStrike" dirty="0">
                          <a:effectLst/>
                        </a:rPr>
                        <a:t> </a:t>
                      </a:r>
                      <a:r>
                        <a:rPr lang="fr-FR" sz="800" u="none" strike="noStrike" dirty="0" err="1">
                          <a:effectLst/>
                        </a:rPr>
                        <a:t>protein</a:t>
                      </a:r>
                      <a:r>
                        <a:rPr lang="fr-FR" sz="800" u="none" strike="noStrike" dirty="0">
                          <a:effectLst/>
                        </a:rPr>
                        <a:t> 5 </a:t>
                      </a:r>
                      <a:endParaRPr lang="fr-FR" sz="800" b="0" i="0" u="none" strike="noStrike" dirty="0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950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virus cycle of lif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RDM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Prenylated Rab acceptor protein 1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726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abac1, Pra1, Praf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7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Ras-related C3 botulinum toxin substrate 1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CU983949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virus entry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Rac1, TC2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25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Vacuolar protein sorting-associated protein 53 homolog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6662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Vsp53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32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u="none" strike="noStrike">
                          <a:effectLst/>
                        </a:rPr>
                        <a:t>Casein kinase II subunit beta </a:t>
                      </a:r>
                      <a:endParaRPr lang="fi-FI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8460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</a:rPr>
                        <a:t>virus response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csnk2b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0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x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  <a:tr h="119388"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plicing factor, arginine/serine-rich 8 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AM857441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u="none" strike="noStrike">
                          <a:effectLst/>
                        </a:rPr>
                        <a:t>SFRS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>
                          <a:effectLst/>
                        </a:rPr>
                        <a:t>1.18</a:t>
                      </a:r>
                      <a:endParaRPr lang="fr-FR" sz="800" b="0" i="0" u="none" strike="noStrike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800" u="none" strike="noStrike" dirty="0">
                          <a:effectLst/>
                        </a:rPr>
                        <a:t> </a:t>
                      </a:r>
                      <a:endParaRPr lang="fr-FR" sz="800" b="0" i="0" u="none" strike="noStrike" dirty="0">
                        <a:effectLst/>
                        <a:latin typeface="Arial"/>
                      </a:endParaRPr>
                    </a:p>
                  </a:txBody>
                  <a:tcPr marL="6681" marR="6681" marT="6681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226711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9</TotalTime>
  <Words>515</Words>
  <Application>Microsoft Office PowerPoint</Application>
  <PresentationFormat>Personnalisé</PresentationFormat>
  <Paragraphs>31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RH</dc:creator>
  <cp:lastModifiedBy>Aude</cp:lastModifiedBy>
  <cp:revision>86</cp:revision>
  <cp:lastPrinted>2012-10-25T11:27:23Z</cp:lastPrinted>
  <dcterms:created xsi:type="dcterms:W3CDTF">2012-10-16T07:53:20Z</dcterms:created>
  <dcterms:modified xsi:type="dcterms:W3CDTF">2013-02-28T13:52:26Z</dcterms:modified>
</cp:coreProperties>
</file>